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1981835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6" d="100"/>
          <a:sy n="26" d="100"/>
        </p:scale>
        <p:origin x="874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243421"/>
            <a:ext cx="10363200" cy="689972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0409223"/>
            <a:ext cx="9144000" cy="4784846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2055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9624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055143"/>
            <a:ext cx="2628900" cy="1679513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055143"/>
            <a:ext cx="7734300" cy="1679513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2015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0700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940830"/>
            <a:ext cx="10515600" cy="8243882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3262702"/>
            <a:ext cx="10515600" cy="4335263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321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275718"/>
            <a:ext cx="5181600" cy="1257456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275718"/>
            <a:ext cx="5181600" cy="1257456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582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55148"/>
            <a:ext cx="10515600" cy="383063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858250"/>
            <a:ext cx="5157787" cy="238095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239203"/>
            <a:ext cx="5157787" cy="1064777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858250"/>
            <a:ext cx="5183188" cy="238095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239203"/>
            <a:ext cx="5183188" cy="1064777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2097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455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728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321223"/>
            <a:ext cx="3932237" cy="462428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853480"/>
            <a:ext cx="6172200" cy="1408387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945505"/>
            <a:ext cx="3932237" cy="1101478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1103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321223"/>
            <a:ext cx="3932237" cy="462428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853480"/>
            <a:ext cx="6172200" cy="1408387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945505"/>
            <a:ext cx="3932237" cy="1101478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527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055148"/>
            <a:ext cx="10515600" cy="38306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275718"/>
            <a:ext cx="10515600" cy="125745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8368679"/>
            <a:ext cx="2743200" cy="10551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B46BD-7713-434F-A3B9-3F9C578353B3}" type="datetimeFigureOut">
              <a:rPr lang="zh-CN" altLang="en-US" smtClean="0"/>
              <a:t>2021-04-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8368679"/>
            <a:ext cx="4114800" cy="10551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8368679"/>
            <a:ext cx="2743200" cy="10551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A7959-9D32-40F1-A08D-C191F192B9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4597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0.png"/><Relationship Id="rId18" Type="http://schemas.openxmlformats.org/officeDocument/2006/relationships/image" Target="../media/image13.pn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12" Type="http://schemas.microsoft.com/office/2007/relationships/hdphoto" Target="../media/hdphoto2.wdp"/><Relationship Id="rId17" Type="http://schemas.microsoft.com/office/2007/relationships/hdphoto" Target="../media/hdphoto4.wdp"/><Relationship Id="rId2" Type="http://schemas.openxmlformats.org/officeDocument/2006/relationships/image" Target="../media/image1.jpeg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5" Type="http://schemas.microsoft.com/office/2007/relationships/hdphoto" Target="../media/hdphoto1.wdp"/><Relationship Id="rId15" Type="http://schemas.openxmlformats.org/officeDocument/2006/relationships/image" Target="../media/image11.png"/><Relationship Id="rId10" Type="http://schemas.openxmlformats.org/officeDocument/2006/relationships/image" Target="../media/image8.jpeg"/><Relationship Id="rId4" Type="http://schemas.openxmlformats.org/officeDocument/2006/relationships/image" Target="../media/image3.png"/><Relationship Id="rId9" Type="http://schemas.openxmlformats.org/officeDocument/2006/relationships/image" Target="../media/image7.jpeg"/><Relationship Id="rId1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19" r="15801"/>
          <a:stretch/>
        </p:blipFill>
        <p:spPr>
          <a:xfrm>
            <a:off x="5361344" y="1607230"/>
            <a:ext cx="2834641" cy="201040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7" r="15173"/>
          <a:stretch/>
        </p:blipFill>
        <p:spPr>
          <a:xfrm rot="10800000">
            <a:off x="5379284" y="3810639"/>
            <a:ext cx="2834641" cy="207216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32" r="16907"/>
          <a:stretch/>
        </p:blipFill>
        <p:spPr>
          <a:xfrm>
            <a:off x="5339123" y="6133767"/>
            <a:ext cx="2856863" cy="219012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37" r="17469"/>
          <a:stretch/>
        </p:blipFill>
        <p:spPr>
          <a:xfrm>
            <a:off x="5350233" y="8609643"/>
            <a:ext cx="2856863" cy="2224399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02" r="8858"/>
          <a:stretch/>
        </p:blipFill>
        <p:spPr>
          <a:xfrm>
            <a:off x="8388673" y="1610837"/>
            <a:ext cx="3124200" cy="2053382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28" r="8445"/>
          <a:stretch/>
        </p:blipFill>
        <p:spPr>
          <a:xfrm>
            <a:off x="8406613" y="6133767"/>
            <a:ext cx="3106260" cy="2193727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79" r="8487"/>
          <a:stretch/>
        </p:blipFill>
        <p:spPr>
          <a:xfrm rot="10800000">
            <a:off x="8434906" y="3810638"/>
            <a:ext cx="3106260" cy="207216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4" r="13441"/>
          <a:stretch/>
        </p:blipFill>
        <p:spPr>
          <a:xfrm>
            <a:off x="8406613" y="8609643"/>
            <a:ext cx="3106260" cy="2224399"/>
          </a:xfrm>
          <a:prstGeom prst="rect">
            <a:avLst/>
          </a:prstGeom>
        </p:spPr>
      </p:pic>
      <p:cxnSp>
        <p:nvCxnSpPr>
          <p:cNvPr id="16" name="直接连接符 15"/>
          <p:cNvCxnSpPr/>
          <p:nvPr/>
        </p:nvCxnSpPr>
        <p:spPr>
          <a:xfrm>
            <a:off x="8444653" y="3479715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8372323" y="326983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μm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5430931" y="3479715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5336219" y="3269830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μm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5448871" y="5666914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5353617" y="5458012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μm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5430932" y="8142207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341926" y="7919981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00μm</a:t>
            </a:r>
            <a:endParaRPr lang="zh-CN" altLang="en-US" sz="1000" dirty="0"/>
          </a:p>
        </p:txBody>
      </p:sp>
      <p:cxnSp>
        <p:nvCxnSpPr>
          <p:cNvPr id="24" name="直接连接符 23"/>
          <p:cNvCxnSpPr/>
          <p:nvPr/>
        </p:nvCxnSpPr>
        <p:spPr>
          <a:xfrm>
            <a:off x="5406213" y="10688478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5348129" y="10442257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00μm</a:t>
            </a:r>
            <a:endParaRPr lang="zh-CN" altLang="en-US" sz="1000" dirty="0"/>
          </a:p>
        </p:txBody>
      </p:sp>
      <p:cxnSp>
        <p:nvCxnSpPr>
          <p:cNvPr id="26" name="直接连接符 25"/>
          <p:cNvCxnSpPr/>
          <p:nvPr/>
        </p:nvCxnSpPr>
        <p:spPr>
          <a:xfrm>
            <a:off x="8454196" y="10688478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8358942" y="10462778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00μm</a:t>
            </a:r>
            <a:endParaRPr lang="zh-CN" altLang="en-US" sz="1000" dirty="0"/>
          </a:p>
        </p:txBody>
      </p:sp>
      <p:cxnSp>
        <p:nvCxnSpPr>
          <p:cNvPr id="28" name="直接连接符 27"/>
          <p:cNvCxnSpPr/>
          <p:nvPr/>
        </p:nvCxnSpPr>
        <p:spPr>
          <a:xfrm>
            <a:off x="8449638" y="8136835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8358942" y="7912003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00μm</a:t>
            </a:r>
            <a:endParaRPr lang="zh-CN" altLang="en-US" sz="1000" dirty="0"/>
          </a:p>
        </p:txBody>
      </p:sp>
      <p:cxnSp>
        <p:nvCxnSpPr>
          <p:cNvPr id="30" name="直接连接符 29"/>
          <p:cNvCxnSpPr/>
          <p:nvPr/>
        </p:nvCxnSpPr>
        <p:spPr>
          <a:xfrm>
            <a:off x="8467577" y="5665078"/>
            <a:ext cx="364453" cy="4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8372323" y="5460219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00μm</a:t>
            </a:r>
            <a:endParaRPr lang="zh-CN" altLang="en-US" sz="1000" dirty="0"/>
          </a:p>
        </p:txBody>
      </p:sp>
      <p:sp>
        <p:nvSpPr>
          <p:cNvPr id="32" name="文本框 31"/>
          <p:cNvSpPr txBox="1"/>
          <p:nvPr/>
        </p:nvSpPr>
        <p:spPr>
          <a:xfrm>
            <a:off x="6155240" y="1180195"/>
            <a:ext cx="1474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-surgery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9375383" y="1193508"/>
            <a:ext cx="1005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ncture</a:t>
            </a:r>
          </a:p>
        </p:txBody>
      </p:sp>
      <p:sp>
        <p:nvSpPr>
          <p:cNvPr id="34" name="文本框 33"/>
          <p:cNvSpPr txBox="1"/>
          <p:nvPr/>
        </p:nvSpPr>
        <p:spPr>
          <a:xfrm rot="16200000">
            <a:off x="4170293" y="2427768"/>
            <a:ext cx="184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-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 rot="16200000">
            <a:off x="4194382" y="4543473"/>
            <a:ext cx="183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franinO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ree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 rot="16200000">
            <a:off x="4176441" y="6974323"/>
            <a:ext cx="183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ia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6200000">
            <a:off x="4176442" y="9633688"/>
            <a:ext cx="183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greca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B8C17A43-770C-4626-9A6D-13ABFE420418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63000" contrast="56000"/>
                    </a14:imgEffect>
                  </a14:imgLayer>
                </a14:imgProps>
              </a:ext>
            </a:extLst>
          </a:blip>
          <a:srcRect l="36824" t="21649" r="2681"/>
          <a:stretch/>
        </p:blipFill>
        <p:spPr>
          <a:xfrm>
            <a:off x="1239565" y="1610837"/>
            <a:ext cx="2168240" cy="2775045"/>
          </a:xfrm>
          <a:prstGeom prst="rect">
            <a:avLst/>
          </a:prstGeom>
        </p:spPr>
      </p:pic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3F50D9B5-0F0F-400D-A9C1-424D31DA46BC}"/>
              </a:ext>
            </a:extLst>
          </p:cNvPr>
          <p:cNvCxnSpPr>
            <a:cxnSpLocks/>
          </p:cNvCxnSpPr>
          <p:nvPr/>
        </p:nvCxnSpPr>
        <p:spPr>
          <a:xfrm>
            <a:off x="1404835" y="3046222"/>
            <a:ext cx="318605" cy="0"/>
          </a:xfrm>
          <a:prstGeom prst="straightConnector1">
            <a:avLst/>
          </a:prstGeom>
          <a:ln w="3175">
            <a:solidFill>
              <a:srgbClr val="FF0000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图片 39">
            <a:extLst>
              <a:ext uri="{FF2B5EF4-FFF2-40B4-BE49-F238E27FC236}">
                <a16:creationId xmlns:a16="http://schemas.microsoft.com/office/drawing/2014/main" id="{6FE4874C-EFA9-4614-9DA4-5E4FC726E271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4000" contrast="18000"/>
                    </a14:imgEffect>
                  </a14:imgLayer>
                </a14:imgProps>
              </a:ext>
            </a:extLst>
          </a:blip>
          <a:srcRect l="2670" t="12444" r="55421" b="18581"/>
          <a:stretch/>
        </p:blipFill>
        <p:spPr>
          <a:xfrm>
            <a:off x="2768239" y="4806785"/>
            <a:ext cx="1641815" cy="2746028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A35C6A05-B595-4702-8525-63A843EBCEB5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1000" contrast="37000"/>
                    </a14:imgEffect>
                  </a14:imgLayer>
                </a14:imgProps>
              </a:ext>
            </a:extLst>
          </a:blip>
          <a:srcRect l="63784" t="2767" r="5253" b="19899"/>
          <a:stretch/>
        </p:blipFill>
        <p:spPr>
          <a:xfrm>
            <a:off x="733630" y="4814289"/>
            <a:ext cx="1700699" cy="2746028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23470912-E1A6-47D3-B567-8B16D55B4994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4000" contrast="27000"/>
                    </a14:imgEffect>
                  </a14:imgLayer>
                </a14:imgProps>
              </a:ext>
            </a:extLst>
          </a:blip>
          <a:srcRect l="60332" t="2868" r="8047" b="4208"/>
          <a:stretch/>
        </p:blipFill>
        <p:spPr>
          <a:xfrm rot="10800000" flipV="1">
            <a:off x="2788129" y="8104647"/>
            <a:ext cx="1648932" cy="2729395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470D2082-AC6E-4E23-92B4-CB3304C3280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39000" contrast="59000"/>
                    </a14:imgEffect>
                  </a14:imgLayer>
                </a14:imgProps>
              </a:ext>
            </a:extLst>
          </a:blip>
          <a:srcRect l="4253" r="60166"/>
          <a:stretch/>
        </p:blipFill>
        <p:spPr>
          <a:xfrm rot="10800000" flipV="1">
            <a:off x="762411" y="8104647"/>
            <a:ext cx="1725287" cy="2729395"/>
          </a:xfrm>
          <a:prstGeom prst="rect">
            <a:avLst/>
          </a:prstGeom>
        </p:spPr>
      </p:pic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A7C56F9B-EA06-4331-9553-3CF66EE7B203}"/>
              </a:ext>
            </a:extLst>
          </p:cNvPr>
          <p:cNvCxnSpPr>
            <a:cxnSpLocks/>
          </p:cNvCxnSpPr>
          <p:nvPr/>
        </p:nvCxnSpPr>
        <p:spPr>
          <a:xfrm>
            <a:off x="2986679" y="9262724"/>
            <a:ext cx="327850" cy="0"/>
          </a:xfrm>
          <a:prstGeom prst="straightConnector1">
            <a:avLst/>
          </a:prstGeom>
          <a:ln w="3175">
            <a:solidFill>
              <a:srgbClr val="FF0000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455C6A83-3095-4123-8995-3C4CE265E101}"/>
              </a:ext>
            </a:extLst>
          </p:cNvPr>
          <p:cNvCxnSpPr>
            <a:cxnSpLocks/>
          </p:cNvCxnSpPr>
          <p:nvPr/>
        </p:nvCxnSpPr>
        <p:spPr>
          <a:xfrm>
            <a:off x="1454425" y="9671461"/>
            <a:ext cx="379893" cy="0"/>
          </a:xfrm>
          <a:prstGeom prst="straightConnector1">
            <a:avLst/>
          </a:prstGeom>
          <a:ln w="3175">
            <a:solidFill>
              <a:srgbClr val="FF0000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4713EFA4-6042-4006-86D2-A13187970B5E}"/>
              </a:ext>
            </a:extLst>
          </p:cNvPr>
          <p:cNvCxnSpPr>
            <a:cxnSpLocks/>
          </p:cNvCxnSpPr>
          <p:nvPr/>
        </p:nvCxnSpPr>
        <p:spPr>
          <a:xfrm flipH="1">
            <a:off x="1310637" y="5909000"/>
            <a:ext cx="504188" cy="0"/>
          </a:xfrm>
          <a:prstGeom prst="straightConnector1">
            <a:avLst/>
          </a:prstGeom>
          <a:ln w="3175">
            <a:solidFill>
              <a:srgbClr val="FF0000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200EDF8E-E392-4F7D-A4AB-8B2B4A680CDA}"/>
              </a:ext>
            </a:extLst>
          </p:cNvPr>
          <p:cNvSpPr txBox="1"/>
          <p:nvPr/>
        </p:nvSpPr>
        <p:spPr>
          <a:xfrm>
            <a:off x="1239565" y="1639853"/>
            <a:ext cx="360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zh-CN" altLang="en-US" sz="2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6DBA4DD6-29B0-4359-B1F0-FA98D4266E09}"/>
              </a:ext>
            </a:extLst>
          </p:cNvPr>
          <p:cNvCxnSpPr>
            <a:cxnSpLocks/>
          </p:cNvCxnSpPr>
          <p:nvPr/>
        </p:nvCxnSpPr>
        <p:spPr>
          <a:xfrm flipH="1">
            <a:off x="3436058" y="6059968"/>
            <a:ext cx="386642" cy="0"/>
          </a:xfrm>
          <a:prstGeom prst="straightConnector1">
            <a:avLst/>
          </a:prstGeom>
          <a:ln w="3175">
            <a:solidFill>
              <a:srgbClr val="FF0000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4D28A397-B8E8-45ED-85B8-B7A6A5B5FAF3}"/>
              </a:ext>
            </a:extLst>
          </p:cNvPr>
          <p:cNvSpPr txBox="1"/>
          <p:nvPr/>
        </p:nvSpPr>
        <p:spPr>
          <a:xfrm>
            <a:off x="764820" y="4843773"/>
            <a:ext cx="360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zh-CN" altLang="en-US" sz="2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BE4645AC-3F47-469A-8C41-FDA69EE64FCD}"/>
              </a:ext>
            </a:extLst>
          </p:cNvPr>
          <p:cNvSpPr txBox="1"/>
          <p:nvPr/>
        </p:nvSpPr>
        <p:spPr>
          <a:xfrm>
            <a:off x="787000" y="8112929"/>
            <a:ext cx="4917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zh-CN" altLang="en-US" sz="2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3E50DBD7-C326-497F-9FDB-DDF2332C409C}"/>
              </a:ext>
            </a:extLst>
          </p:cNvPr>
          <p:cNvSpPr txBox="1"/>
          <p:nvPr/>
        </p:nvSpPr>
        <p:spPr>
          <a:xfrm rot="16200000">
            <a:off x="-842267" y="2673568"/>
            <a:ext cx="272325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-gauge needle puncture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L4-5 IVD  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7B0D583-0A6C-452A-B0DB-C88CE3908379}"/>
              </a:ext>
            </a:extLst>
          </p:cNvPr>
          <p:cNvSpPr txBox="1"/>
          <p:nvPr/>
        </p:nvSpPr>
        <p:spPr>
          <a:xfrm>
            <a:off x="232133" y="4454625"/>
            <a:ext cx="2723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-surgery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1874844F-ACF6-4B3B-9FE1-9F039727A5FA}"/>
              </a:ext>
            </a:extLst>
          </p:cNvPr>
          <p:cNvSpPr txBox="1"/>
          <p:nvPr/>
        </p:nvSpPr>
        <p:spPr>
          <a:xfrm>
            <a:off x="2203964" y="4464533"/>
            <a:ext cx="2723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ncture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BD3C7E7E-ADDD-4D19-8995-4AE61A0D3A4B}"/>
              </a:ext>
            </a:extLst>
          </p:cNvPr>
          <p:cNvSpPr txBox="1"/>
          <p:nvPr/>
        </p:nvSpPr>
        <p:spPr>
          <a:xfrm>
            <a:off x="263428" y="7735315"/>
            <a:ext cx="2723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-surgery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8FA4A81-2284-456A-9D95-F0A1FC645DCA}"/>
              </a:ext>
            </a:extLst>
          </p:cNvPr>
          <p:cNvSpPr txBox="1"/>
          <p:nvPr/>
        </p:nvSpPr>
        <p:spPr>
          <a:xfrm>
            <a:off x="2154932" y="7765165"/>
            <a:ext cx="272325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ncture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7CBA6F8-7421-4061-A8C6-C997EFF0AEF0}"/>
              </a:ext>
            </a:extLst>
          </p:cNvPr>
          <p:cNvSpPr txBox="1"/>
          <p:nvPr/>
        </p:nvSpPr>
        <p:spPr>
          <a:xfrm rot="16200000">
            <a:off x="-543043" y="5971486"/>
            <a:ext cx="196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teral  X-ray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B819657E-6AB6-468B-A588-42D704C57FF6}"/>
              </a:ext>
            </a:extLst>
          </p:cNvPr>
          <p:cNvSpPr txBox="1"/>
          <p:nvPr/>
        </p:nvSpPr>
        <p:spPr>
          <a:xfrm rot="16200000">
            <a:off x="-549211" y="9275881"/>
            <a:ext cx="196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I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203C51B1-B58E-4DF1-909D-40035505E8AD}"/>
              </a:ext>
            </a:extLst>
          </p:cNvPr>
          <p:cNvSpPr txBox="1"/>
          <p:nvPr/>
        </p:nvSpPr>
        <p:spPr>
          <a:xfrm>
            <a:off x="5406213" y="1610837"/>
            <a:ext cx="360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5181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</TotalTime>
  <Words>36</Words>
  <Application>Microsoft Office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rescz</dc:creator>
  <cp:lastModifiedBy>a</cp:lastModifiedBy>
  <cp:revision>32</cp:revision>
  <dcterms:created xsi:type="dcterms:W3CDTF">2021-03-25T13:22:08Z</dcterms:created>
  <dcterms:modified xsi:type="dcterms:W3CDTF">2021-04-16T13:15:22Z</dcterms:modified>
</cp:coreProperties>
</file>